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4"/>
  </p:sldMasterIdLst>
  <p:sldIdLst>
    <p:sldId id="256" r:id="rId5"/>
  </p:sldIdLst>
  <p:sldSz cx="6858000" cy="75120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79C527E-B991-4BA3-9C5C-CF5FBD09152C}" v="4" dt="2021-05-14T06:18:58.002"/>
    <p1510:client id="{99C6C0A8-C315-4358-8412-E08E4B2B82F6}" v="1" dt="2021-05-04T19:41:53.11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1" d="100"/>
          <a:sy n="61" d="100"/>
        </p:scale>
        <p:origin x="1896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Virtanen, Jenni M E" userId="S::jennivir@ad.helsinki.fi::f80e8c45-5774-4515-9117-daf82f3b85d5" providerId="AD" clId="Web-{579C527E-B991-4BA3-9C5C-CF5FBD09152C}"/>
    <pc:docChg chg="modSld">
      <pc:chgData name="Virtanen, Jenni M E" userId="S::jennivir@ad.helsinki.fi::f80e8c45-5774-4515-9117-daf82f3b85d5" providerId="AD" clId="Web-{579C527E-B991-4BA3-9C5C-CF5FBD09152C}" dt="2021-05-14T06:18:53.612" v="0" actId="20577"/>
      <pc:docMkLst>
        <pc:docMk/>
      </pc:docMkLst>
      <pc:sldChg chg="modSp">
        <pc:chgData name="Virtanen, Jenni M E" userId="S::jennivir@ad.helsinki.fi::f80e8c45-5774-4515-9117-daf82f3b85d5" providerId="AD" clId="Web-{579C527E-B991-4BA3-9C5C-CF5FBD09152C}" dt="2021-05-14T06:18:53.612" v="0" actId="20577"/>
        <pc:sldMkLst>
          <pc:docMk/>
          <pc:sldMk cId="2657272097" sldId="256"/>
        </pc:sldMkLst>
        <pc:spChg chg="mod">
          <ac:chgData name="Virtanen, Jenni M E" userId="S::jennivir@ad.helsinki.fi::f80e8c45-5774-4515-9117-daf82f3b85d5" providerId="AD" clId="Web-{579C527E-B991-4BA3-9C5C-CF5FBD09152C}" dt="2021-05-14T06:18:53.612" v="0" actId="20577"/>
          <ac:spMkLst>
            <pc:docMk/>
            <pc:sldMk cId="2657272097" sldId="256"/>
            <ac:spMk id="7" creationId="{E1696F1E-E15D-4E94-946C-23384D6ECFBF}"/>
          </ac:spMkLst>
        </pc:spChg>
      </pc:sldChg>
    </pc:docChg>
  </pc:docChgLst>
  <pc:docChgLst>
    <pc:chgData name="Jenni Virtanen" userId="fc933a9b98c39aaa" providerId="LiveId" clId="{99C6C0A8-C315-4358-8412-E08E4B2B82F6}"/>
    <pc:docChg chg="custSel modSld">
      <pc:chgData name="Jenni Virtanen" userId="fc933a9b98c39aaa" providerId="LiveId" clId="{99C6C0A8-C315-4358-8412-E08E4B2B82F6}" dt="2021-05-04T19:41:59.776" v="4" actId="1076"/>
      <pc:docMkLst>
        <pc:docMk/>
      </pc:docMkLst>
      <pc:sldChg chg="addSp delSp modSp mod">
        <pc:chgData name="Jenni Virtanen" userId="fc933a9b98c39aaa" providerId="LiveId" clId="{99C6C0A8-C315-4358-8412-E08E4B2B82F6}" dt="2021-05-04T19:41:59.776" v="4" actId="1076"/>
        <pc:sldMkLst>
          <pc:docMk/>
          <pc:sldMk cId="2657272097" sldId="256"/>
        </pc:sldMkLst>
        <pc:picChg chg="del">
          <ac:chgData name="Jenni Virtanen" userId="fc933a9b98c39aaa" providerId="LiveId" clId="{99C6C0A8-C315-4358-8412-E08E4B2B82F6}" dt="2021-05-04T19:41:49.737" v="0" actId="478"/>
          <ac:picMkLst>
            <pc:docMk/>
            <pc:sldMk cId="2657272097" sldId="256"/>
            <ac:picMk id="5" creationId="{57BE70C3-CEDB-437D-9F9C-720A93458A4D}"/>
          </ac:picMkLst>
        </pc:picChg>
        <pc:picChg chg="add mod">
          <ac:chgData name="Jenni Virtanen" userId="fc933a9b98c39aaa" providerId="LiveId" clId="{99C6C0A8-C315-4358-8412-E08E4B2B82F6}" dt="2021-05-04T19:41:59.776" v="4" actId="1076"/>
          <ac:picMkLst>
            <pc:docMk/>
            <pc:sldMk cId="2657272097" sldId="256"/>
            <ac:picMk id="9" creationId="{7297820C-FE2E-4BC1-B58B-90582B290944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Otsikko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229403"/>
            <a:ext cx="5829300" cy="261530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3945566"/>
            <a:ext cx="5143500" cy="181367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i-FI"/>
              <a:t>Muokkaa alaotsikon perustyyliä napsautt.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9E59B-FB52-4399-956D-A44E6F482486}" type="datetimeFigureOut">
              <a:rPr lang="fi-FI" smtClean="0"/>
              <a:t>13.5.2021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9B806-AC17-4F48-9D23-EB5CF0E669B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460336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Otsikko ja pystysuora tek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9E59B-FB52-4399-956D-A44E6F482486}" type="datetimeFigureOut">
              <a:rPr lang="fi-FI" smtClean="0"/>
              <a:t>13.5.2021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9B806-AC17-4F48-9D23-EB5CF0E669B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6541864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Pystysuora otsikko ja tek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399947"/>
            <a:ext cx="1478756" cy="6366115"/>
          </a:xfrm>
        </p:spPr>
        <p:txBody>
          <a:bodyPr vert="eaVert"/>
          <a:lstStyle/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399947"/>
            <a:ext cx="4350544" cy="6366115"/>
          </a:xfrm>
        </p:spPr>
        <p:txBody>
          <a:bodyPr vert="eaVert"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9E59B-FB52-4399-956D-A44E6F482486}" type="datetimeFigureOut">
              <a:rPr lang="fi-FI" smtClean="0"/>
              <a:t>13.5.2021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9B806-AC17-4F48-9D23-EB5CF0E669B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7466068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Otsikko ja sisält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9E59B-FB52-4399-956D-A44E6F482486}" type="datetimeFigureOut">
              <a:rPr lang="fi-FI" smtClean="0"/>
              <a:t>13.5.2021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9B806-AC17-4F48-9D23-EB5CF0E669B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4464824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Osan ylätunnis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1872798"/>
            <a:ext cx="5915025" cy="3124804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5027164"/>
            <a:ext cx="5915025" cy="1643260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i-FI"/>
              <a:t>Muokkaa tekstin perustyylejä napsauttamall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9E59B-FB52-4399-956D-A44E6F482486}" type="datetimeFigureOut">
              <a:rPr lang="fi-FI" smtClean="0"/>
              <a:t>13.5.2021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9B806-AC17-4F48-9D23-EB5CF0E669B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42883340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Kaksi sisältökohdet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1999735"/>
            <a:ext cx="2914650" cy="4766327"/>
          </a:xfrm>
        </p:spPr>
        <p:txBody>
          <a:bodyPr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1999735"/>
            <a:ext cx="2914650" cy="4766327"/>
          </a:xfrm>
        </p:spPr>
        <p:txBody>
          <a:bodyPr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9E59B-FB52-4399-956D-A44E6F482486}" type="datetimeFigureOut">
              <a:rPr lang="fi-FI" smtClean="0"/>
              <a:t>13.5.2021</a:t>
            </a:fld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9B806-AC17-4F48-9D23-EB5CF0E669B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6265621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tail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399949"/>
            <a:ext cx="5915025" cy="1451982"/>
          </a:xfrm>
        </p:spPr>
        <p:txBody>
          <a:bodyPr/>
          <a:lstStyle/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1841496"/>
            <a:ext cx="2901255" cy="90248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i-FI"/>
              <a:t>Muokkaa tekstin perustyylejä napsauttamall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2743985"/>
            <a:ext cx="2901255" cy="4035989"/>
          </a:xfrm>
        </p:spPr>
        <p:txBody>
          <a:bodyPr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1841496"/>
            <a:ext cx="2915543" cy="90248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i-FI"/>
              <a:t>Muokkaa tekstin perustyylejä napsauttamall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2743985"/>
            <a:ext cx="2915543" cy="4035989"/>
          </a:xfrm>
        </p:spPr>
        <p:txBody>
          <a:bodyPr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9E59B-FB52-4399-956D-A44E6F482486}" type="datetimeFigureOut">
              <a:rPr lang="fi-FI" smtClean="0"/>
              <a:t>13.5.2021</a:t>
            </a:fld>
            <a:endParaRPr lang="fi-FI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9B806-AC17-4F48-9D23-EB5CF0E669B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5655019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Vain otsikk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9E59B-FB52-4399-956D-A44E6F482486}" type="datetimeFigureOut">
              <a:rPr lang="fi-FI" smtClean="0"/>
              <a:t>13.5.2021</a:t>
            </a:fld>
            <a:endParaRPr lang="fi-FI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9B806-AC17-4F48-9D23-EB5CF0E669B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1799228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yhjä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9E59B-FB52-4399-956D-A44E6F482486}" type="datetimeFigureOut">
              <a:rPr lang="fi-FI" smtClean="0"/>
              <a:t>13.5.2021</a:t>
            </a:fld>
            <a:endParaRPr lang="fi-FI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9B806-AC17-4F48-9D23-EB5CF0E669B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883388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Kuvatekstillinen sisält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00803"/>
            <a:ext cx="2211884" cy="1752812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081598"/>
            <a:ext cx="3471863" cy="5338424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253615"/>
            <a:ext cx="2211884" cy="417510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i-FI"/>
              <a:t>Muokkaa tekstin perustyylejä napsauttamall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9E59B-FB52-4399-956D-A44E6F482486}" type="datetimeFigureOut">
              <a:rPr lang="fi-FI" smtClean="0"/>
              <a:t>13.5.2021</a:t>
            </a:fld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9B806-AC17-4F48-9D23-EB5CF0E669B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3942278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uvatekstillinen kuv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00803"/>
            <a:ext cx="2211884" cy="1752812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081598"/>
            <a:ext cx="3471863" cy="5338424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i-FI"/>
              <a:t>Lisää kuva napsauttamalla kuvakett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253615"/>
            <a:ext cx="2211884" cy="417510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i-FI"/>
              <a:t>Muokkaa tekstin perustyylejä napsauttamall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9E59B-FB52-4399-956D-A44E6F482486}" type="datetimeFigureOut">
              <a:rPr lang="fi-FI" smtClean="0"/>
              <a:t>13.5.2021</a:t>
            </a:fld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9B806-AC17-4F48-9D23-EB5CF0E669B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40513311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399949"/>
            <a:ext cx="5915025" cy="145198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i-FI"/>
              <a:t>Muokkaa ots. perustyyl. napsautt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1999735"/>
            <a:ext cx="5915025" cy="476632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6962559"/>
            <a:ext cx="1543050" cy="3999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19E59B-FB52-4399-956D-A44E6F482486}" type="datetimeFigureOut">
              <a:rPr lang="fi-FI" smtClean="0"/>
              <a:t>13.5.2021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6962559"/>
            <a:ext cx="2314575" cy="3999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6962559"/>
            <a:ext cx="1543050" cy="3999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19B806-AC17-4F48-9D23-EB5CF0E669B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40314128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Alaotsikko 6">
            <a:extLst>
              <a:ext uri="{FF2B5EF4-FFF2-40B4-BE49-F238E27FC236}">
                <a16:creationId xmlns:a16="http://schemas.microsoft.com/office/drawing/2014/main" id="{E1696F1E-E15D-4E94-946C-23384D6ECFB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668064" y="6010567"/>
            <a:ext cx="5743245" cy="1052386"/>
          </a:xfrm>
        </p:spPr>
        <p:txBody>
          <a:bodyPr vert="horz" lIns="91440" tIns="45720" rIns="91440" bIns="45720" rtlCol="0" anchor="t">
            <a:normAutofit/>
          </a:bodyPr>
          <a:lstStyle/>
          <a:p>
            <a:pPr algn="l"/>
            <a:r>
              <a:rPr lang="fi-FI" b="1" dirty="0" err="1">
                <a:latin typeface="Times New Roman"/>
                <a:cs typeface="Times New Roman"/>
              </a:rPr>
              <a:t>Figure</a:t>
            </a:r>
            <a:r>
              <a:rPr lang="fi-FI" b="1" dirty="0">
                <a:latin typeface="Times New Roman"/>
                <a:cs typeface="Times New Roman"/>
              </a:rPr>
              <a:t> S3. </a:t>
            </a:r>
            <a:r>
              <a:rPr lang="fi-FI" dirty="0" err="1">
                <a:latin typeface="Times New Roman"/>
                <a:cs typeface="Times New Roman"/>
              </a:rPr>
              <a:t>Genetic</a:t>
            </a:r>
            <a:r>
              <a:rPr lang="fi-FI" dirty="0">
                <a:latin typeface="Times New Roman"/>
                <a:cs typeface="Times New Roman"/>
              </a:rPr>
              <a:t> </a:t>
            </a:r>
            <a:r>
              <a:rPr lang="fi-FI" dirty="0" err="1">
                <a:latin typeface="Times New Roman"/>
                <a:cs typeface="Times New Roman"/>
              </a:rPr>
              <a:t>distance</a:t>
            </a:r>
            <a:r>
              <a:rPr lang="fi-FI" dirty="0">
                <a:latin typeface="Times New Roman"/>
                <a:cs typeface="Times New Roman"/>
              </a:rPr>
              <a:t> </a:t>
            </a:r>
            <a:r>
              <a:rPr lang="fi-FI" dirty="0" err="1">
                <a:latin typeface="Times New Roman"/>
                <a:cs typeface="Times New Roman"/>
              </a:rPr>
              <a:t>within</a:t>
            </a:r>
            <a:r>
              <a:rPr lang="fi-FI" dirty="0">
                <a:latin typeface="Times New Roman"/>
                <a:cs typeface="Times New Roman"/>
              </a:rPr>
              <a:t> </a:t>
            </a:r>
            <a:r>
              <a:rPr lang="fi-FI" dirty="0" err="1">
                <a:latin typeface="Times New Roman"/>
                <a:cs typeface="Times New Roman"/>
              </a:rPr>
              <a:t>feral</a:t>
            </a:r>
            <a:r>
              <a:rPr lang="fi-FI" dirty="0">
                <a:latin typeface="Times New Roman"/>
                <a:cs typeface="Times New Roman"/>
              </a:rPr>
              <a:t> </a:t>
            </a:r>
            <a:r>
              <a:rPr lang="fi-FI" dirty="0" err="1">
                <a:latin typeface="Times New Roman"/>
                <a:cs typeface="Times New Roman"/>
              </a:rPr>
              <a:t>mink</a:t>
            </a:r>
            <a:r>
              <a:rPr lang="fi-FI" dirty="0">
                <a:latin typeface="Times New Roman"/>
                <a:cs typeface="Times New Roman"/>
              </a:rPr>
              <a:t> in </a:t>
            </a:r>
            <a:r>
              <a:rPr lang="fi-FI" dirty="0" err="1">
                <a:latin typeface="Times New Roman"/>
                <a:cs typeface="Times New Roman"/>
              </a:rPr>
              <a:t>different</a:t>
            </a:r>
            <a:r>
              <a:rPr lang="fi-FI" dirty="0">
                <a:latin typeface="Times New Roman"/>
                <a:cs typeface="Times New Roman"/>
              </a:rPr>
              <a:t> </a:t>
            </a:r>
            <a:r>
              <a:rPr lang="fi-FI" dirty="0" err="1">
                <a:latin typeface="Times New Roman"/>
                <a:cs typeface="Times New Roman"/>
              </a:rPr>
              <a:t>study</a:t>
            </a:r>
            <a:r>
              <a:rPr lang="fi-FI" dirty="0">
                <a:latin typeface="Times New Roman"/>
                <a:cs typeface="Times New Roman"/>
              </a:rPr>
              <a:t> </a:t>
            </a:r>
            <a:r>
              <a:rPr lang="fi-FI" dirty="0" err="1">
                <a:latin typeface="Times New Roman"/>
                <a:cs typeface="Times New Roman"/>
              </a:rPr>
              <a:t>sites</a:t>
            </a:r>
            <a:r>
              <a:rPr lang="fi-FI" dirty="0">
                <a:latin typeface="Times New Roman"/>
                <a:cs typeface="Times New Roman"/>
              </a:rPr>
              <a:t> and </a:t>
            </a:r>
            <a:r>
              <a:rPr lang="fi-FI" dirty="0" err="1">
                <a:latin typeface="Times New Roman"/>
                <a:cs typeface="Times New Roman"/>
              </a:rPr>
              <a:t>farms</a:t>
            </a:r>
            <a:r>
              <a:rPr lang="fi-FI" dirty="0">
                <a:latin typeface="Times New Roman"/>
                <a:cs typeface="Times New Roman"/>
              </a:rPr>
              <a:t> in </a:t>
            </a:r>
            <a:r>
              <a:rPr lang="fi-FI" dirty="0" err="1">
                <a:latin typeface="Times New Roman"/>
                <a:cs typeface="Times New Roman"/>
              </a:rPr>
              <a:t>two</a:t>
            </a:r>
            <a:r>
              <a:rPr lang="fi-FI" dirty="0">
                <a:latin typeface="Times New Roman"/>
                <a:cs typeface="Times New Roman"/>
              </a:rPr>
              <a:t> </a:t>
            </a:r>
            <a:r>
              <a:rPr lang="fi-FI" dirty="0" err="1">
                <a:latin typeface="Times New Roman"/>
                <a:cs typeface="Times New Roman"/>
              </a:rPr>
              <a:t>genomic</a:t>
            </a:r>
            <a:r>
              <a:rPr lang="fi-FI" dirty="0">
                <a:latin typeface="Times New Roman"/>
                <a:cs typeface="Times New Roman"/>
              </a:rPr>
              <a:t> </a:t>
            </a:r>
            <a:r>
              <a:rPr lang="fi-FI" dirty="0" err="1">
                <a:latin typeface="Times New Roman"/>
                <a:cs typeface="Times New Roman"/>
              </a:rPr>
              <a:t>regions</a:t>
            </a:r>
            <a:r>
              <a:rPr lang="fi-FI" dirty="0">
                <a:latin typeface="Times New Roman"/>
                <a:cs typeface="Times New Roman"/>
              </a:rPr>
              <a:t>. </a:t>
            </a:r>
            <a:r>
              <a:rPr lang="fi-FI" dirty="0" err="1">
                <a:latin typeface="Times New Roman"/>
                <a:cs typeface="Times New Roman"/>
              </a:rPr>
              <a:t>Study</a:t>
            </a:r>
            <a:r>
              <a:rPr lang="fi-FI" dirty="0">
                <a:latin typeface="Times New Roman"/>
                <a:cs typeface="Times New Roman"/>
              </a:rPr>
              <a:t> </a:t>
            </a:r>
            <a:r>
              <a:rPr lang="fi-FI" dirty="0" err="1">
                <a:latin typeface="Times New Roman"/>
                <a:cs typeface="Times New Roman"/>
              </a:rPr>
              <a:t>sites</a:t>
            </a:r>
            <a:r>
              <a:rPr lang="fi-FI" dirty="0">
                <a:latin typeface="Times New Roman"/>
                <a:cs typeface="Times New Roman"/>
              </a:rPr>
              <a:t> </a:t>
            </a:r>
            <a:r>
              <a:rPr lang="fi-FI" dirty="0" err="1">
                <a:latin typeface="Times New Roman"/>
                <a:cs typeface="Times New Roman"/>
              </a:rPr>
              <a:t>are</a:t>
            </a:r>
            <a:r>
              <a:rPr lang="fi-FI" dirty="0">
                <a:latin typeface="Times New Roman"/>
                <a:cs typeface="Times New Roman"/>
              </a:rPr>
              <a:t> </a:t>
            </a:r>
            <a:r>
              <a:rPr lang="fi-FI" dirty="0" err="1">
                <a:latin typeface="Times New Roman"/>
                <a:cs typeface="Times New Roman"/>
              </a:rPr>
              <a:t>marked</a:t>
            </a:r>
            <a:r>
              <a:rPr lang="fi-FI" dirty="0">
                <a:latin typeface="Times New Roman"/>
                <a:cs typeface="Times New Roman"/>
              </a:rPr>
              <a:t> </a:t>
            </a:r>
            <a:r>
              <a:rPr lang="fi-FI" dirty="0" err="1">
                <a:latin typeface="Times New Roman"/>
                <a:cs typeface="Times New Roman"/>
              </a:rPr>
              <a:t>based</a:t>
            </a:r>
            <a:r>
              <a:rPr lang="fi-FI" dirty="0">
                <a:latin typeface="Times New Roman"/>
                <a:cs typeface="Times New Roman"/>
              </a:rPr>
              <a:t> on </a:t>
            </a:r>
            <a:r>
              <a:rPr lang="fi-FI" dirty="0" err="1">
                <a:latin typeface="Times New Roman"/>
                <a:cs typeface="Times New Roman"/>
              </a:rPr>
              <a:t>their</a:t>
            </a:r>
            <a:r>
              <a:rPr lang="fi-FI" dirty="0">
                <a:latin typeface="Times New Roman"/>
                <a:cs typeface="Times New Roman"/>
              </a:rPr>
              <a:t> </a:t>
            </a:r>
            <a:r>
              <a:rPr lang="fi-FI" dirty="0" err="1">
                <a:latin typeface="Times New Roman"/>
                <a:cs typeface="Times New Roman"/>
              </a:rPr>
              <a:t>geographic</a:t>
            </a:r>
            <a:r>
              <a:rPr lang="fi-FI" dirty="0">
                <a:latin typeface="Times New Roman"/>
                <a:cs typeface="Times New Roman"/>
              </a:rPr>
              <a:t> </a:t>
            </a:r>
            <a:r>
              <a:rPr lang="fi-FI" dirty="0" err="1">
                <a:latin typeface="Times New Roman"/>
                <a:cs typeface="Times New Roman"/>
              </a:rPr>
              <a:t>region</a:t>
            </a:r>
            <a:r>
              <a:rPr lang="fi-FI" dirty="0">
                <a:latin typeface="Times New Roman"/>
                <a:cs typeface="Times New Roman"/>
              </a:rPr>
              <a:t>.  </a:t>
            </a:r>
            <a:endParaRPr lang="fi-FI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Kuva 8">
            <a:extLst>
              <a:ext uri="{FF2B5EF4-FFF2-40B4-BE49-F238E27FC236}">
                <a16:creationId xmlns:a16="http://schemas.microsoft.com/office/drawing/2014/main" id="{7297820C-FE2E-4BC1-B58B-90582B29094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7015" y="172027"/>
            <a:ext cx="6465341" cy="58385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572720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ema">
  <a:themeElements>
    <a:clrScheme name="Office-te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e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e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3846AD7339D8140AC36BDD6F700082D" ma:contentTypeVersion="9" ma:contentTypeDescription="Create a new document." ma:contentTypeScope="" ma:versionID="3599035802281abc035690d8cc15a22a">
  <xsd:schema xmlns:xsd="http://www.w3.org/2001/XMLSchema" xmlns:xs="http://www.w3.org/2001/XMLSchema" xmlns:p="http://schemas.microsoft.com/office/2006/metadata/properties" xmlns:ns2="ccd30b50-d302-4e1e-b69a-6cac3021f000" targetNamespace="http://schemas.microsoft.com/office/2006/metadata/properties" ma:root="true" ma:fieldsID="f498ad90c7f485b8e87b2eda6449f06f" ns2:_="">
    <xsd:import namespace="ccd30b50-d302-4e1e-b69a-6cac3021f000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ServiceAutoKeyPoints" minOccurs="0"/>
                <xsd:element ref="ns2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cd30b50-d302-4e1e-b69a-6cac3021f000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4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KeyPoints" ma:index="15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6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66F89F69-24A4-4AB6-B020-6B751203CA3C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2.xml><?xml version="1.0" encoding="utf-8"?>
<ds:datastoreItem xmlns:ds="http://schemas.openxmlformats.org/officeDocument/2006/customXml" ds:itemID="{1B6EB2D7-E341-4276-817F-466FB85F4012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F4BCA73A-C410-4854-943F-C9C378E6F308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29</Words>
  <Application>Microsoft Office PowerPoint</Application>
  <PresentationFormat>Mukautettu</PresentationFormat>
  <Paragraphs>1</Paragraphs>
  <Slides>1</Slides>
  <Notes>0</Notes>
  <HiddenSlides>0</HiddenSlides>
  <MMClips>0</MMClips>
  <ScaleCrop>false</ScaleCrop>
  <HeadingPairs>
    <vt:vector size="4" baseType="variant">
      <vt:variant>
        <vt:lpstr>Teema</vt:lpstr>
      </vt:variant>
      <vt:variant>
        <vt:i4>1</vt:i4>
      </vt:variant>
      <vt:variant>
        <vt:lpstr>Dian otsikot</vt:lpstr>
      </vt:variant>
      <vt:variant>
        <vt:i4>1</vt:i4>
      </vt:variant>
    </vt:vector>
  </HeadingPairs>
  <TitlesOfParts>
    <vt:vector size="2" baseType="lpstr">
      <vt:lpstr>Office-teema</vt:lpstr>
      <vt:lpstr>PowerPoint-esity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esitys</dc:title>
  <dc:creator>Jenni Virtanen</dc:creator>
  <cp:lastModifiedBy>Jenni Virtanen</cp:lastModifiedBy>
  <cp:revision>4</cp:revision>
  <dcterms:created xsi:type="dcterms:W3CDTF">2021-05-04T19:35:19Z</dcterms:created>
  <dcterms:modified xsi:type="dcterms:W3CDTF">2021-05-14T06:19:0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3846AD7339D8140AC36BDD6F700082D</vt:lpwstr>
  </property>
</Properties>
</file>